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A670B-96E0-FB0D-72EB-72599DB32D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FCAE1E-0A27-2028-59FF-49F4B92609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5E6948-63B0-AF9C-AD7F-5CB755E0E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A4B838-850B-24EC-2901-4AD7BA206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140292-B58D-3921-CED3-1F96AFC63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397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6884D-E80C-C67A-F2CF-9E6EC556E1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6BC09F-627C-A6A4-5AF4-573563A0C1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DEED36-9DE9-5658-D9F3-D6388D5FE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9257D-11C5-2AB9-FDFC-43B798BA6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DA5DAB-DC0C-07DE-D253-30761EA17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13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536E88-8170-F455-FFD8-566855968E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AC1296-CAAC-A1FD-420C-7D2C6E5E81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F8C1FB-038D-44AE-E3DB-F2E31F40B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94F40A-5A1B-BF76-8E9B-0926C4A4E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B3D7FA-B5E0-9DD0-3C7E-FE857FB65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810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AA2C6-E811-1D30-C019-A4A4923718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AFF911-3484-2B7F-6925-8013C4586E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55054A-239C-8BD1-DD1A-7A9A87676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E04EB3-46B0-7876-6C71-C167E2E4E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85AE16-8777-B045-6DC5-9C101554F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036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CBEAC7-755D-032D-4313-DC0B065FFE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BE1331-28D1-C719-D6B8-B1C69C0181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3682C6-9D83-8D36-68ED-39F9C669E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0C9535-C851-DE66-13FF-10767D40F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639EA-3E78-D1E2-CD0A-54227DDA3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701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2C853F-4059-8E2C-E682-1DFD73751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1AAAD4-33F8-0F2F-9E78-64F0CF3DA8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3BC50E-01E3-4444-3D83-595C5240B7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F11280-525C-85C1-62FC-8D924BE10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6D9F19-7B4C-6AC5-2D18-0BF873B9F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CE8F7E-5891-0C75-4530-E5152EACC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911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87E5E-DCA8-13C6-F371-D2D23F98D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A3576B-66EC-07D3-9644-49152B54A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D3EE4E-CF8E-C1A2-6005-E37C356DAD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05BBF7-00D8-F7D0-A971-9569834FAB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84B078-93A1-C631-E66F-64478BAC35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F80866-630B-B95D-D939-7CF0A6329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3D02C27-DE49-758A-25DD-7B22CB546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3B08CF-2F26-E6F7-4AE0-C7439085DE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04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4B377-92C9-44D1-0085-15C60749D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F3BFEF-D9D1-2F64-AC1A-1D775BC8C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A43FD1-22C8-F63D-8DB9-27FDAD315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1686B5-90D7-CDF5-7C2A-B06AF6022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743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6C91509-A3DC-A162-3621-99CBC3042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04794A-258E-05FF-9510-D39F37455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1D570E-2184-E46C-F7A0-D77D3607B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355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437480-D6C6-1BD9-9EC0-8C25AD541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85CF20-F632-1C74-6A47-C9535FEB69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3CC9B7-93D7-3A17-BCA8-D82350BB2D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349A0-943A-53CE-9988-71B07560A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04A61C-92AA-6533-28C6-3D74C0BBB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824879-7BF0-2B0D-C65A-0C1565C77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307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9FCBF-8E95-4C38-C672-A26BF86B0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A14883-C1D8-36C2-3FC9-F5A67B7760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9612D9-855C-0946-CECA-142EABE10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3D66C1-2768-52E3-554B-34A9AF4BC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AEA865-F866-08E7-8CBD-197E22DD8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578CBB-803F-6220-2BFA-2AF433A20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051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1D7AFC-7B2B-30D2-BB49-F71A60BEE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11C7BE-200E-9D27-CBB8-6FC341D7C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C815A4-CD92-5FE8-BDE5-FA3B7BD71A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C686F-FDFE-4F28-B6DA-C2F89CAE9E8F}" type="datetimeFigureOut">
              <a:rPr lang="en-US" smtClean="0"/>
              <a:t>07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A23435-E6DC-FD11-3DB1-40E48335CF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732511-7F96-193B-A1CD-E6F3E76E43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CE5B8D-A32E-4A31-9E03-D946CCB1C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588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6CE436BC-2104-6F43-EC91-6D83AFA7580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73"/>
          <a:stretch/>
        </p:blipFill>
        <p:spPr>
          <a:xfrm>
            <a:off x="3759959" y="3810999"/>
            <a:ext cx="4945892" cy="2984568"/>
          </a:xfrm>
          <a:prstGeom prst="rect">
            <a:avLst/>
          </a:prstGeom>
        </p:spPr>
      </p:pic>
      <p:pic>
        <p:nvPicPr>
          <p:cNvPr id="5" name="Picture 4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94780BE3-9CCC-E41E-0D3B-AE6ACBA323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59"/>
          <a:stretch/>
        </p:blipFill>
        <p:spPr>
          <a:xfrm>
            <a:off x="6337428" y="933408"/>
            <a:ext cx="4692522" cy="2844043"/>
          </a:xfrm>
          <a:prstGeom prst="rect">
            <a:avLst/>
          </a:prstGeom>
        </p:spPr>
      </p:pic>
      <p:pic>
        <p:nvPicPr>
          <p:cNvPr id="3" name="Picture 2" descr="A graph of numbers with different colored lines&#10;&#10;Description automatically generated">
            <a:extLst>
              <a:ext uri="{FF2B5EF4-FFF2-40B4-BE49-F238E27FC236}">
                <a16:creationId xmlns:a16="http://schemas.microsoft.com/office/drawing/2014/main" id="{8E82AD94-56A6-07FE-B7B1-8E98C3BE6CC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98"/>
          <a:stretch/>
        </p:blipFill>
        <p:spPr>
          <a:xfrm>
            <a:off x="1440650" y="933408"/>
            <a:ext cx="4777957" cy="28763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E0B6923-706B-4F6F-8EA9-91758E4299B5}"/>
              </a:ext>
            </a:extLst>
          </p:cNvPr>
          <p:cNvSpPr txBox="1"/>
          <p:nvPr/>
        </p:nvSpPr>
        <p:spPr>
          <a:xfrm>
            <a:off x="387176" y="343877"/>
            <a:ext cx="3355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ry Figure 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2066C0-F203-4678-B09D-4F861B7EBE90}"/>
              </a:ext>
            </a:extLst>
          </p:cNvPr>
          <p:cNvSpPr txBox="1"/>
          <p:nvPr/>
        </p:nvSpPr>
        <p:spPr>
          <a:xfrm>
            <a:off x="2087195" y="629224"/>
            <a:ext cx="3849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69F4C85-8005-8F14-2C1B-3CECE69D0B80}"/>
              </a:ext>
            </a:extLst>
          </p:cNvPr>
          <p:cNvSpPr/>
          <p:nvPr/>
        </p:nvSpPr>
        <p:spPr>
          <a:xfrm>
            <a:off x="2489223" y="971712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No change”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C052333-2B0F-FCD3-FBF0-E8B71C6FFC7B}"/>
              </a:ext>
            </a:extLst>
          </p:cNvPr>
          <p:cNvSpPr/>
          <p:nvPr/>
        </p:nvSpPr>
        <p:spPr>
          <a:xfrm>
            <a:off x="4588898" y="971711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LHL”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D704C60-1A3A-D0E0-37F6-B72E098E3080}"/>
              </a:ext>
            </a:extLst>
          </p:cNvPr>
          <p:cNvSpPr/>
          <p:nvPr/>
        </p:nvSpPr>
        <p:spPr>
          <a:xfrm>
            <a:off x="2472227" y="2297995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MHH”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514D60C-ED74-6989-C0AA-BEF1F727D795}"/>
              </a:ext>
            </a:extLst>
          </p:cNvPr>
          <p:cNvSpPr/>
          <p:nvPr/>
        </p:nvSpPr>
        <p:spPr>
          <a:xfrm>
            <a:off x="4607173" y="2299053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LMM”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BEE509-26F2-43AE-BF35-CA51DF2B9D6D}"/>
              </a:ext>
            </a:extLst>
          </p:cNvPr>
          <p:cNvSpPr txBox="1"/>
          <p:nvPr/>
        </p:nvSpPr>
        <p:spPr>
          <a:xfrm>
            <a:off x="6654801" y="687969"/>
            <a:ext cx="3849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B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F59F411-FE48-D7D5-EB8E-821902C81F11}"/>
              </a:ext>
            </a:extLst>
          </p:cNvPr>
          <p:cNvSpPr/>
          <p:nvPr/>
        </p:nvSpPr>
        <p:spPr>
          <a:xfrm>
            <a:off x="7215261" y="979466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No change”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0CC1870-AB2A-7D00-728A-8EFAECCBD6CB}"/>
              </a:ext>
            </a:extLst>
          </p:cNvPr>
          <p:cNvSpPr/>
          <p:nvPr/>
        </p:nvSpPr>
        <p:spPr>
          <a:xfrm>
            <a:off x="7215261" y="2295574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LMM”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34BEE5E-6446-9035-0490-46E094021595}"/>
              </a:ext>
            </a:extLst>
          </p:cNvPr>
          <p:cNvSpPr/>
          <p:nvPr/>
        </p:nvSpPr>
        <p:spPr>
          <a:xfrm>
            <a:off x="9462065" y="2292687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LHH”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6B949D0-5E55-B682-3D63-CE731FC80A12}"/>
              </a:ext>
            </a:extLst>
          </p:cNvPr>
          <p:cNvSpPr/>
          <p:nvPr/>
        </p:nvSpPr>
        <p:spPr>
          <a:xfrm>
            <a:off x="9432755" y="982848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HLM”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D0D66D-8642-48FC-B802-15F39F498FB0}"/>
              </a:ext>
            </a:extLst>
          </p:cNvPr>
          <p:cNvSpPr txBox="1"/>
          <p:nvPr/>
        </p:nvSpPr>
        <p:spPr>
          <a:xfrm>
            <a:off x="4677514" y="3608077"/>
            <a:ext cx="3355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749A4E9-C76A-ADFB-4E4C-9DA1E38566DF}"/>
              </a:ext>
            </a:extLst>
          </p:cNvPr>
          <p:cNvSpPr/>
          <p:nvPr/>
        </p:nvSpPr>
        <p:spPr>
          <a:xfrm>
            <a:off x="4864651" y="5211816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MML”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811103F-F355-B1DE-574E-ABA15A478ACB}"/>
              </a:ext>
            </a:extLst>
          </p:cNvPr>
          <p:cNvSpPr/>
          <p:nvPr/>
        </p:nvSpPr>
        <p:spPr>
          <a:xfrm>
            <a:off x="6989714" y="5216238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LHL”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5B00231-C11E-F11C-6751-198313D702CE}"/>
              </a:ext>
            </a:extLst>
          </p:cNvPr>
          <p:cNvSpPr/>
          <p:nvPr/>
        </p:nvSpPr>
        <p:spPr>
          <a:xfrm>
            <a:off x="6998120" y="3863268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MLL”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991D2BE-637F-CD7E-AB17-A376E3DF9B90}"/>
              </a:ext>
            </a:extLst>
          </p:cNvPr>
          <p:cNvSpPr/>
          <p:nvPr/>
        </p:nvSpPr>
        <p:spPr>
          <a:xfrm>
            <a:off x="4864651" y="3851185"/>
            <a:ext cx="821070" cy="11165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dirty="0">
                <a:solidFill>
                  <a:schemeClr val="tx1"/>
                </a:solidFill>
              </a:rPr>
              <a:t>Cluster “No change”</a:t>
            </a:r>
          </a:p>
        </p:txBody>
      </p:sp>
    </p:spTree>
    <p:extLst>
      <p:ext uri="{BB962C8B-B14F-4D97-AF65-F5344CB8AC3E}">
        <p14:creationId xmlns:p14="http://schemas.microsoft.com/office/powerpoint/2010/main" val="379630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dasivan, Sudha</dc:creator>
  <cp:lastModifiedBy>Sadasivan, Sudha</cp:lastModifiedBy>
  <cp:revision>2</cp:revision>
  <dcterms:created xsi:type="dcterms:W3CDTF">2023-07-10T18:48:55Z</dcterms:created>
  <dcterms:modified xsi:type="dcterms:W3CDTF">2023-07-14T18:11:49Z</dcterms:modified>
</cp:coreProperties>
</file>